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0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2EA"/>
    <a:srgbClr val="FF9674"/>
    <a:srgbClr val="FD7855"/>
    <a:srgbClr val="9B1614"/>
    <a:srgbClr val="FE937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64"/>
    <p:restoredTop sz="96327"/>
  </p:normalViewPr>
  <p:slideViewPr>
    <p:cSldViewPr snapToGrid="0" snapToObjects="1">
      <p:cViewPr varScale="1">
        <p:scale>
          <a:sx n="152" d="100"/>
          <a:sy n="152" d="100"/>
        </p:scale>
        <p:origin x="140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813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24908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777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08073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6149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9888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90574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321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9246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81259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67399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08F5FA-E6BE-0541-BF1E-B402AB74CC66}" type="datetimeFigureOut">
              <a:rPr lang="en-GB" smtClean="0"/>
              <a:t>29/08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D41A99-B33A-DC44-ACE7-70B8060816A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04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:a16="http://schemas.microsoft.com/office/drawing/2014/main" id="{71E580A1-A861-7547-AE2E-83AEA3D7FFE9}"/>
              </a:ext>
            </a:extLst>
          </p:cNvPr>
          <p:cNvSpPr txBox="1"/>
          <p:nvPr/>
        </p:nvSpPr>
        <p:spPr>
          <a:xfrm>
            <a:off x="4509612" y="6248457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200" b="1">
                <a:latin typeface="Arial" panose="020B0604020202020204" pitchFamily="34" charset="0"/>
                <a:cs typeface="Arial" panose="020B0604020202020204" pitchFamily="34" charset="0"/>
              </a:rPr>
              <a:t>S4 Figure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C5DA641D-AB41-7AB2-3F21-5C3C9C292960}"/>
              </a:ext>
            </a:extLst>
          </p:cNvPr>
          <p:cNvGrpSpPr/>
          <p:nvPr/>
        </p:nvGrpSpPr>
        <p:grpSpPr>
          <a:xfrm>
            <a:off x="1592323" y="1305432"/>
            <a:ext cx="6341345" cy="4571900"/>
            <a:chOff x="1592323" y="1305432"/>
            <a:chExt cx="6341345" cy="4571900"/>
          </a:xfrm>
        </p:grpSpPr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B4FF5E44-26ED-EC0F-7A16-9A20714CFD0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2078999">
              <a:off x="2232467" y="1305432"/>
              <a:ext cx="2927286" cy="4571900"/>
            </a:xfrm>
            <a:prstGeom prst="rect">
              <a:avLst/>
            </a:prstGeom>
          </p:spPr>
        </p:pic>
        <p:sp>
          <p:nvSpPr>
            <p:cNvPr id="168" name="TextBox 167">
              <a:extLst>
                <a:ext uri="{FF2B5EF4-FFF2-40B4-BE49-F238E27FC236}">
                  <a16:creationId xmlns:a16="http://schemas.microsoft.com/office/drawing/2014/main" id="{272A42B8-D907-60A3-099C-A693B5E98364}"/>
                </a:ext>
              </a:extLst>
            </p:cNvPr>
            <p:cNvSpPr txBox="1"/>
            <p:nvPr/>
          </p:nvSpPr>
          <p:spPr>
            <a:xfrm>
              <a:off x="2420449" y="2013586"/>
              <a:ext cx="896400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GH17 domain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3FDB7CE3-E63C-380E-6B90-611C600378D8}"/>
                </a:ext>
              </a:extLst>
            </p:cNvPr>
            <p:cNvSpPr txBox="1"/>
            <p:nvPr/>
          </p:nvSpPr>
          <p:spPr>
            <a:xfrm>
              <a:off x="1592323" y="4610605"/>
              <a:ext cx="819455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GT2 domain</a:t>
              </a:r>
            </a:p>
          </p:txBody>
        </p:sp>
        <p:sp>
          <p:nvSpPr>
            <p:cNvPr id="170" name="TextBox 169">
              <a:extLst>
                <a:ext uri="{FF2B5EF4-FFF2-40B4-BE49-F238E27FC236}">
                  <a16:creationId xmlns:a16="http://schemas.microsoft.com/office/drawing/2014/main" id="{F85D8D01-F84A-7716-F91F-B4A8301A6239}"/>
                </a:ext>
              </a:extLst>
            </p:cNvPr>
            <p:cNvSpPr txBox="1"/>
            <p:nvPr/>
          </p:nvSpPr>
          <p:spPr>
            <a:xfrm>
              <a:off x="2248914" y="3176803"/>
              <a:ext cx="704039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GB" sz="900">
                  <a:latin typeface="Arial" panose="020B0604020202020204" pitchFamily="34" charset="0"/>
                  <a:cs typeface="Arial" panose="020B0604020202020204" pitchFamily="34" charset="0"/>
                </a:rPr>
                <a:t>TM region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Picture 19" descr="A picture containing flower, plant&#10;&#10;Description automatically generated">
              <a:extLst>
                <a:ext uri="{FF2B5EF4-FFF2-40B4-BE49-F238E27FC236}">
                  <a16:creationId xmlns:a16="http://schemas.microsoft.com/office/drawing/2014/main" id="{EE1CC5B6-8CEE-5B7F-A767-7F7F6927FE2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944948" y="1952678"/>
              <a:ext cx="2858625" cy="2921016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04DD3168-485C-C21D-6A71-7197A2AD2B40}"/>
                </a:ext>
              </a:extLst>
            </p:cNvPr>
            <p:cNvSpPr txBox="1"/>
            <p:nvPr/>
          </p:nvSpPr>
          <p:spPr>
            <a:xfrm>
              <a:off x="2098976" y="2406584"/>
              <a:ext cx="110158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ellulose polymer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3753F61-D3D0-312C-C0B9-7F701382FD9F}"/>
                </a:ext>
              </a:extLst>
            </p:cNvPr>
            <p:cNvSpPr txBox="1"/>
            <p:nvPr/>
          </p:nvSpPr>
          <p:spPr>
            <a:xfrm>
              <a:off x="6832084" y="4518413"/>
              <a:ext cx="1101584" cy="2308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pPr algn="r"/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Cellulose polymer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41A9D80A-C06C-E437-5C7F-1241F206C43F}"/>
              </a:ext>
            </a:extLst>
          </p:cNvPr>
          <p:cNvSpPr txBox="1"/>
          <p:nvPr/>
        </p:nvSpPr>
        <p:spPr>
          <a:xfrm rot="19267842">
            <a:off x="1617125" y="3067297"/>
            <a:ext cx="7476856" cy="355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chemeClr val="bg1">
                    <a:lumMod val="75000"/>
                  </a:schemeClr>
                </a:solidFill>
              </a:rPr>
              <a:t>DRAFT FIGURE – DRAFT FIGURE – DRAFT FIGURE – DRAFT FIGURE – DRAFT FIGURE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2379E06-38EE-519E-1FB0-C6B7903F16F0}"/>
              </a:ext>
            </a:extLst>
          </p:cNvPr>
          <p:cNvSpPr txBox="1"/>
          <p:nvPr/>
        </p:nvSpPr>
        <p:spPr>
          <a:xfrm>
            <a:off x="5349082" y="1167433"/>
            <a:ext cx="2277431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B) Transmembrane helic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94FD863-04D2-B150-08C2-A75E0F3998B5}"/>
              </a:ext>
            </a:extLst>
          </p:cNvPr>
          <p:cNvSpPr txBox="1"/>
          <p:nvPr/>
        </p:nvSpPr>
        <p:spPr>
          <a:xfrm>
            <a:off x="2923114" y="1167433"/>
            <a:ext cx="1697901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GB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Pf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SBW25 Orpha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2CB8A14-7098-7E54-D3D0-C7E9643F85D0}"/>
              </a:ext>
            </a:extLst>
          </p:cNvPr>
          <p:cNvSpPr txBox="1"/>
          <p:nvPr/>
        </p:nvSpPr>
        <p:spPr>
          <a:xfrm>
            <a:off x="5598933" y="1358752"/>
            <a:ext cx="212775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and signal peptide</a:t>
            </a:r>
          </a:p>
        </p:txBody>
      </p:sp>
    </p:spTree>
    <p:extLst>
      <p:ext uri="{BB962C8B-B14F-4D97-AF65-F5344CB8AC3E}">
        <p14:creationId xmlns:p14="http://schemas.microsoft.com/office/powerpoint/2010/main" val="15390347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3</TotalTime>
  <Words>40</Words>
  <Application>Microsoft Macintosh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w Spiers</dc:creator>
  <cp:lastModifiedBy>Andrew Spiers</cp:lastModifiedBy>
  <cp:revision>34</cp:revision>
  <cp:lastPrinted>2022-08-23T12:16:10Z</cp:lastPrinted>
  <dcterms:created xsi:type="dcterms:W3CDTF">2021-11-26T17:28:20Z</dcterms:created>
  <dcterms:modified xsi:type="dcterms:W3CDTF">2022-08-29T14:27:36Z</dcterms:modified>
</cp:coreProperties>
</file>